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1" d="100"/>
          <a:sy n="71" d="100"/>
        </p:scale>
        <p:origin x="69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47610-6898-46F3-AA5F-C24472F63F6F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82ED2-27ED-4B43-9917-DD4BA312E6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73555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47610-6898-46F3-AA5F-C24472F63F6F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82ED2-27ED-4B43-9917-DD4BA312E6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39900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47610-6898-46F3-AA5F-C24472F63F6F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82ED2-27ED-4B43-9917-DD4BA312E6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54501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47610-6898-46F3-AA5F-C24472F63F6F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82ED2-27ED-4B43-9917-DD4BA312E6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53389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47610-6898-46F3-AA5F-C24472F63F6F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82ED2-27ED-4B43-9917-DD4BA312E6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33395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47610-6898-46F3-AA5F-C24472F63F6F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82ED2-27ED-4B43-9917-DD4BA312E6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25579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47610-6898-46F3-AA5F-C24472F63F6F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82ED2-27ED-4B43-9917-DD4BA312E6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83427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47610-6898-46F3-AA5F-C24472F63F6F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82ED2-27ED-4B43-9917-DD4BA312E6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19861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47610-6898-46F3-AA5F-C24472F63F6F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82ED2-27ED-4B43-9917-DD4BA312E6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67064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47610-6898-46F3-AA5F-C24472F63F6F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82ED2-27ED-4B43-9917-DD4BA312E6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24694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47610-6898-46F3-AA5F-C24472F63F6F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82ED2-27ED-4B43-9917-DD4BA312E6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74541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947610-6898-46F3-AA5F-C24472F63F6F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F82ED2-27ED-4B43-9917-DD4BA312E6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06075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 txBox="1">
            <a:spLocks/>
          </p:cNvSpPr>
          <p:nvPr/>
        </p:nvSpPr>
        <p:spPr>
          <a:xfrm>
            <a:off x="218940" y="90153"/>
            <a:ext cx="11973059" cy="1034071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sz="3200" dirty="0">
                <a:solidFill>
                  <a:srgbClr val="0070C0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NJ-tree &amp; PCA between 271 </a:t>
            </a:r>
            <a:r>
              <a:rPr lang="en-US" sz="3200" i="1" dirty="0">
                <a:solidFill>
                  <a:srgbClr val="0070C0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Ipomoea </a:t>
            </a:r>
            <a:r>
              <a:rPr lang="en-US" sz="3200" i="1" dirty="0" err="1">
                <a:solidFill>
                  <a:srgbClr val="0070C0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batatas</a:t>
            </a:r>
            <a:r>
              <a:rPr lang="en-US" sz="3200" i="1" dirty="0">
                <a:solidFill>
                  <a:srgbClr val="0070C0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 </a:t>
            </a:r>
            <a:r>
              <a:rPr lang="en-GB" sz="3200" dirty="0">
                <a:solidFill>
                  <a:srgbClr val="0070C0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accessions </a:t>
            </a:r>
            <a:r>
              <a:rPr lang="en-US" sz="3200" dirty="0">
                <a:solidFill>
                  <a:srgbClr val="0070C0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computed with 7,591  polymorphic  SNPs based on the state of collection</a:t>
            </a:r>
            <a:endParaRPr lang="en-GB" sz="3200" dirty="0">
              <a:solidFill>
                <a:srgbClr val="FF0000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66610" y="1638678"/>
            <a:ext cx="6186172" cy="4765139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>
            <a:off x="5401880" y="5207153"/>
            <a:ext cx="1162498" cy="147732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>
                <a:solidFill>
                  <a:schemeClr val="accent4">
                    <a:lumMod val="75000"/>
                  </a:schemeClr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Abia</a:t>
            </a:r>
            <a:endParaRPr lang="en-US" b="1" dirty="0">
              <a:solidFill>
                <a:schemeClr val="accent4">
                  <a:lumMod val="75000"/>
                </a:schemeClr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  <a:p>
            <a:r>
              <a:rPr lang="en-US" b="1" dirty="0" err="1">
                <a:solidFill>
                  <a:srgbClr val="7030A0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Atlantique</a:t>
            </a:r>
            <a:r>
              <a:rPr lang="en-US" b="1" dirty="0">
                <a:solidFill>
                  <a:srgbClr val="0070C0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n-US" b="1" dirty="0" err="1">
                <a:solidFill>
                  <a:srgbClr val="FF0000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Dosso</a:t>
            </a:r>
            <a:endParaRPr lang="en-US" b="1" dirty="0">
              <a:solidFill>
                <a:srgbClr val="FF0000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  <a:p>
            <a:r>
              <a:rPr lang="en-US" b="1" dirty="0">
                <a:solidFill>
                  <a:schemeClr val="bg1">
                    <a:lumMod val="65000"/>
                  </a:schemeClr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Ebony</a:t>
            </a:r>
            <a:r>
              <a:rPr lang="en-US" b="1" dirty="0">
                <a:solidFill>
                  <a:srgbClr val="0070C0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n-US" b="1" dirty="0" err="1">
                <a:solidFill>
                  <a:srgbClr val="0000FF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Tilaberi</a:t>
            </a:r>
            <a:endParaRPr lang="en-GB" b="1" dirty="0">
              <a:solidFill>
                <a:srgbClr val="0000FF"/>
              </a:solidFill>
            </a:endParaRPr>
          </a:p>
        </p:txBody>
      </p:sp>
      <p:sp>
        <p:nvSpPr>
          <p:cNvPr id="9" name="Oval 8"/>
          <p:cNvSpPr/>
          <p:nvPr/>
        </p:nvSpPr>
        <p:spPr>
          <a:xfrm rot="18975307">
            <a:off x="6550837" y="2317077"/>
            <a:ext cx="1862379" cy="4160646"/>
          </a:xfrm>
          <a:prstGeom prst="ellipse">
            <a:avLst/>
          </a:prstGeom>
          <a:solidFill>
            <a:schemeClr val="accent4">
              <a:lumMod val="60000"/>
              <a:lumOff val="40000"/>
              <a:alpha val="17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Oval 9"/>
          <p:cNvSpPr/>
          <p:nvPr/>
        </p:nvSpPr>
        <p:spPr>
          <a:xfrm rot="18975307">
            <a:off x="7763748" y="1587945"/>
            <a:ext cx="3620606" cy="4160646"/>
          </a:xfrm>
          <a:prstGeom prst="ellipse">
            <a:avLst/>
          </a:prstGeom>
          <a:solidFill>
            <a:srgbClr val="7030A0">
              <a:alpha val="17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" name="Oval 10"/>
          <p:cNvSpPr/>
          <p:nvPr/>
        </p:nvSpPr>
        <p:spPr>
          <a:xfrm rot="18691451">
            <a:off x="7477633" y="2389802"/>
            <a:ext cx="1133559" cy="3322408"/>
          </a:xfrm>
          <a:prstGeom prst="ellipse">
            <a:avLst/>
          </a:prstGeom>
          <a:solidFill>
            <a:schemeClr val="accent3">
              <a:lumMod val="50000"/>
              <a:alpha val="17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B96E79D-0CFE-F814-7F6F-F06692F15F4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2907" y="1936984"/>
            <a:ext cx="3824523" cy="38585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845501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4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Arial Narrow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udarnaud</dc:creator>
  <cp:lastModifiedBy>Mahaman Mourtala Issa Zakari</cp:lastModifiedBy>
  <cp:revision>2</cp:revision>
  <dcterms:created xsi:type="dcterms:W3CDTF">2023-01-02T11:44:28Z</dcterms:created>
  <dcterms:modified xsi:type="dcterms:W3CDTF">2024-10-09T18:26:40Z</dcterms:modified>
</cp:coreProperties>
</file>